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ACBEC2-5E72-4BB9-B55D-FCBD074DD4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870A10-5AC9-4438-8C0B-4E3B504BF6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E077A6-577C-4AA1-BF65-F3D294EF57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4EE747-6FCA-4386-9C04-034054137E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CC6A26-7E8D-4463-9F2E-2D8DD920E7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8027D-2E87-46D7-B85F-FAA7862B72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038D6-AA76-4796-ABF5-A483C1AAB9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53E61-E4C7-4C1F-AEA8-985B82CC4F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A7CB4-003D-49F2-8494-520179A601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9E226-3F9B-494A-9D13-C354AC2B56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09EB5A-2DC0-458E-94F7-0BC8B13033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3A3CEE-4FD7-469B-AAD0-645D781DBC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2877B6-0042-41C2-8B5C-7EEC503787D8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33360" y="270000"/>
          <a:ext cx="5832360" cy="7354800"/>
        </p:xfrm>
        <a:graphic>
          <a:graphicData uri="http://schemas.openxmlformats.org/drawingml/2006/table">
            <a:tbl>
              <a:tblPr/>
              <a:tblGrid>
                <a:gridCol w="677880"/>
                <a:gridCol w="3166920"/>
                <a:gridCol w="331920"/>
                <a:gridCol w="330120"/>
                <a:gridCol w="331920"/>
                <a:gridCol w="331920"/>
                <a:gridCol w="330120"/>
                <a:gridCol w="331560"/>
              </a:tblGrid>
              <a:tr h="2808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GEN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DESCRIP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 gridSpan="3"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CONTR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3"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8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TREAT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7f7f7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IM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im-1 oncogen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TCH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tch homolog 1 , translocation-associated(Drosophilia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TCH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tch homolog 2 (Drosophilia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NAI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nail homolog 1(Drosophilia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0.6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NT2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ingless-type MMTV integration site family, member 2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U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sminogen activator, urokinase recepto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FBR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ansforming growth factor, beta receptorIII(betaglycan 300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PC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ypican 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MGA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MGA2:high mobility group AT-hook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NMT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MBT1: deleted in malignant brain tumors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R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RP1: low density lipoprotein-related protein 1 (alpha-2-macroglobulin receptor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9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USP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USP5: dual specificity phosphatase 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7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S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SR: insulin recepto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PB41L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PB41L3: erythrocyte membrane protein band 4.1 like 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R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RP1_ neuropilin 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RPJ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RPJ: protein tyrosine phosphatase, receptor type,J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AG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AG1: jagged 1(Alagille syndrome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RP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RP5: low density lipoprotein receptor-related protein 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FS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FS1:wolfram syndrome 1 (wolframin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USP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USP4: dual specificity phosphatase 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XL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XL2:lysyl oxidase-like 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RP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RP2: neuropilin 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TGB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TGB3: integrin, beta 3 (platelet gycoprotein IIIa, antigen CD61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56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MA7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MA7A: semaphorin 7A, GPI membrane anchor (John Milton Hagen blood group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9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BE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BE1:collagen and calcium binding EGFR domains 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56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RP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RP8: low density lipoprotein receptor-related protein B, apolipoprotein e recepto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RT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RT15: keratin 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L4A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L4A1: collagen, type IV, alpha 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1B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L1B: interleukin 1, bet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9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SIG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SIG1: insulin indiced gene 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NMT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NMT38: NDA (cytosine-5-)methyltransferase 3 bet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100A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100A7: S100 calcium binding protein A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4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FB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ansforming growth factor, beta 1(Camurati-Engelmann disease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.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MAD 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MAD3: SMAD, mothers against DPP homolog 3(Drosophila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9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AR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ARA: peroxisome proliferative activated receptor, alph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MD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MDS: GDP-mannose 4,6-dehydrat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76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A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AT: carnitine acetyltransfer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PCT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PCTL: glutaminyl-peptide cyclotransferase-lik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IB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IB2: tribbles homolog 2(Drosophila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GL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GLL: monogllyceride lip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A: adenosine deamin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2.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0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QL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QLE:squalene epoxid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456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LNT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LNT2: UDP-N-acetyl-alpha-D-galactosamine: polypeptide N-acetylgalactosaminyltra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C17A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C17A5: solute carrier family 17(anion/sugar transporter), member 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6GA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6GAL1: ST6 beta-galactosamide alpha-2,6- slalytransferase 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P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PP1: ectonucleotide pyrophosphatase/phosphodiesterase 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IP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IPG: lipase, endothelia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ST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ST2: cystatin S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3.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6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8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IAA11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IAA1199: KIAA11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AMTS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AMTSL1: ADAMTS-like 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AL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AL1: Kallmann syndrome 1 sequ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N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N1: fibronectin 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TR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TRS: protein tyrosine phosphatase, receptor type, 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TGA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TGA6: integrin, alpha 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1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P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P14: matrix metallopeptidase 14(membrane-inserted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7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TGA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TGA10: integrin, alpha 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XNA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XNA2: plexin A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L4A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L4A2: collagen. type IV, alpha 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76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2B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2B4: ATPase, Ca++ transporting, plasma membrane 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1.9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3.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8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B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BD: thrombomodulin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800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X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X: lysyl oxidas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6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440"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TB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TBP1: latent transforming growth factor beta binding protein 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4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57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160" rIns="2160" tIns="216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_tradnl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2.5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160" marR="2160">
                    <a:lnL w="28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2-27T22:05:30Z</dcterms:created>
  <dc:creator>VeRo</dc:creator>
  <dc:description/>
  <dc:language>en-US</dc:language>
  <cp:lastModifiedBy>b.ar</cp:lastModifiedBy>
  <dcterms:modified xsi:type="dcterms:W3CDTF">2015-07-17T12:04:08Z</dcterms:modified>
  <cp:revision>7</cp:revision>
  <dc:subject/>
  <dc:title>Diapositiva 1</dc:title>
</cp:coreProperties>
</file>